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82" autoAdjust="0"/>
    <p:restoredTop sz="94660"/>
  </p:normalViewPr>
  <p:slideViewPr>
    <p:cSldViewPr snapToGrid="0">
      <p:cViewPr varScale="1">
        <p:scale>
          <a:sx n="83" d="100"/>
          <a:sy n="83" d="100"/>
        </p:scale>
        <p:origin x="31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CA18D3-7E6E-4603-A2A8-D244B1C90C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BF7AFBE-2AD9-4047-BA10-7CF7AF674E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542DC7-A6EA-4522-832B-2F3DD545E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F54C24C-7B21-4692-A114-599CDDA0A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57AE6C-80AF-4CD4-B41C-CF9119347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755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94E5A1-3927-4D21-A826-9D59EBC53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FF15E0A-E657-4ACA-BEE6-5E815D789C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847F0D-E58A-4664-9E9D-28F7A0632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910F32-7B6F-4810-8E0E-8C4B0E066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042F9D-95E3-4DB2-941F-58DD92518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8244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0927BA6-9629-447E-9BF2-A874249C79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CA148EC-ACE7-4249-8D4D-32F1CDB12B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E750E2B-99E7-489E-9100-3025CB9FD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46B483-BC40-495F-8BC2-B52666ABD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ECEF8C-D285-4B73-A179-F9B8CF90C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672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385C32-A401-4CA0-AC12-BC48467DB8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52307C2-FF5A-4DE7-8D1A-DED244599F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23673F-C59C-4CF3-9C2B-C554DC1415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6B51AA-BD4A-4625-9B94-912396290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D65633-B5F0-4F13-A269-0A31DF149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286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AFBE63-A31D-42B8-92C2-539D300D5B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04F7711-286E-4702-ABF2-A545E180DE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55D5A1-C8A4-48D4-A54B-1AEB788D6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0BA96B-F171-4D79-BE5F-C4376C412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99FC2C-5F84-4C4C-9C54-6FCF2C057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855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0EFA55-C870-462E-B0B7-210AA201F2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C16CCBE-FDCF-434E-9A40-C92AC783C7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72D8E4E-4A84-4AF5-8BB6-1757601416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348B83-2589-4D74-A0AD-81704F208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FC3CD71-A517-457F-AF34-FD744CFF6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4AAC1D8-D5F4-4337-BF8B-66567337F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4569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C9A558-F1F5-468D-AE4A-C0C515C9D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45F518-8403-4D46-99F3-426C3043A0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1E6F0DD-4156-47CD-97DA-15A6B7176C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76ADC73-39FD-4B97-A1A7-E49E5751A6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DA36B03-4617-4779-A8A1-2DD2F4EF6E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0A30A34-89E7-4707-A720-7E37092A6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62DCD26-42E0-41E5-BC0B-34AA12CDD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E40BD1D-39CB-4DE8-91D4-2992806C8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7959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659772-FF03-4B42-9F7E-D1C550DAB4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2FAFF5C-CAB3-42B4-B34F-F8A252D42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BFF0F42-F2B3-4C38-A66C-0D793917A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06F2E0A-BACE-4472-AD8B-9A2DFDE16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8602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9A5C01B-79AE-4611-BAEA-879D71E011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762EEB6-1D28-4944-8B1C-81EABE05A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BC1F8D1-C47E-45D5-9A55-D65B302C3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499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7C90F3-67AF-4FDF-AC85-DD76C9614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5277A7B-CA41-4CB4-8153-0370F4D23A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10ED119-8C86-4737-9B9E-ECC3B09DC5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ADF999D-A46D-4CA1-9440-1779929E5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E509FC7-3A6B-4C8D-9D41-32E821801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F5B2B3A-EC7C-4690-8597-7DCC40792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01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95FF79-D8B1-4225-B5D7-68DCF611DE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059B922-F528-40C2-B4BB-A0023060AE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59E17E-099A-422E-9EF8-72C1977133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1E43A6-DD28-4C56-B933-C2A4A4FA2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208490D-0AA0-418C-B90A-F8430749D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6D1E71-C241-44A4-A4EE-72543C56C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287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5B056AC-5425-4702-B974-9DDD062A4D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525A3AD-8EB7-4A6F-9FDA-6D88D239E5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1C5CF4-331A-4AD7-B84B-837FCD3C1E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65A17-084C-4801-8940-84E8E1E9BB99}" type="datetimeFigureOut">
              <a:rPr lang="zh-CN" altLang="en-US" smtClean="0"/>
              <a:t>2025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D6AC5E-7A8F-4082-B616-2800D625AE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E49F3A-F93C-4843-8181-C09ACC9E69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0429F-0B8D-489E-A86A-402F55783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1342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9D8A548A-AA2E-41A3-8D5A-F712C0A39A3C}"/>
              </a:ext>
            </a:extLst>
          </p:cNvPr>
          <p:cNvGrpSpPr/>
          <p:nvPr/>
        </p:nvGrpSpPr>
        <p:grpSpPr>
          <a:xfrm>
            <a:off x="0" y="1348547"/>
            <a:ext cx="6860801" cy="7208905"/>
            <a:chOff x="0" y="90489"/>
            <a:chExt cx="6860801" cy="7208905"/>
          </a:xfrm>
        </p:grpSpPr>
        <p:pic>
          <p:nvPicPr>
            <p:cNvPr id="1036" name="Picture 12">
              <a:extLst>
                <a:ext uri="{FF2B5EF4-FFF2-40B4-BE49-F238E27FC236}">
                  <a16:creationId xmlns:a16="http://schemas.microsoft.com/office/drawing/2014/main" id="{2CFE14F4-6F9D-4DE2-AB20-228B88ECA03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90489"/>
              <a:ext cx="6860801" cy="56435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BBE34FAE-8684-4075-B4C7-EF23C0E989A5}"/>
                </a:ext>
              </a:extLst>
            </p:cNvPr>
            <p:cNvSpPr txBox="1"/>
            <p:nvPr/>
          </p:nvSpPr>
          <p:spPr>
            <a:xfrm>
              <a:off x="0" y="5822066"/>
              <a:ext cx="6858000" cy="1477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Figure S1 – Data curation flowchart of DDA-Bench. (A) Data curation pipeline for benchmarking datasets. (B) Data curation pipeline for baseline performance values. AI-based assistants were utilized in curating performance tables from PDF files. All AI-produced results were manually reviewed and integrated into the database manually.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20495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5</Words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12-16T08:41:18Z</dcterms:created>
  <dcterms:modified xsi:type="dcterms:W3CDTF">2025-12-17T04:21:07Z</dcterms:modified>
</cp:coreProperties>
</file>